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D7AC3CCA-C797-4891-BE02-D94E43425B78}" styleName="スタイル (中間)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1FECB4D8-DB02-4DC6-A0A2-4F2EBAE1DC90}" styleName="中間スタイル 1 - アクセント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248"/>
    <p:restoredTop sz="96327"/>
  </p:normalViewPr>
  <p:slideViewPr>
    <p:cSldViewPr snapToGrid="0">
      <p:cViewPr varScale="1">
        <p:scale>
          <a:sx n="128" d="100"/>
          <a:sy n="128" d="100"/>
        </p:scale>
        <p:origin x="24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936F136-6D1A-22F4-54F9-251B3C17CB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8055CA9-92A9-7B5E-34BC-3989F062A9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4A19C0D-25A9-A297-F67F-C1494F4D24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6E87D10-FFC8-59B7-9D51-61B578267B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E02A607-35D5-2D48-75FF-74ECB3ED6A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9997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B26364-B68D-FCD5-7F93-D50A407BC5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7171425-1434-2035-DDC4-1CC58701DB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F7D4A9E-34F9-D609-AFA6-9A8C40BB78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E830CAC-C78D-2E08-1D35-782E8F8803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46BB0B9-1144-299C-26FE-C324B5FB42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82897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3328F34-5ECB-132F-33F4-F538D24330C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B5E2F72-C9E7-4C3D-CCEB-E9824037FA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58AB107-598A-2CBE-64EE-5AEEE67B3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C00A6AE-763D-95A8-A2C4-D0AE4FCE44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828E38A-9CD3-759D-0519-632018DB91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4424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91D52B6-7F14-92BA-98A1-F5EBE8BB28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A5B4499-1C26-5267-8234-480AA16896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8EA0ED7-39A2-A43A-410F-8D3CE26F4E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E0FBB07-3624-1DE3-9944-2C18259DA9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8B2C524-7394-006C-22C2-7416025E22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5482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748C0D7-D208-EC5C-EE37-E27F0E15E2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A76A718-C3EF-819D-C1B0-8B6036F0B1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CA8EAA4-27EF-DA32-5156-1640E9B4E0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F08AAFF-7574-64BC-01A1-AD39491977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7F3AFFC-3DEE-9138-9798-79C94B5C22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5370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DAA7F0F-5639-2F94-3C9F-F159325706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6BC7D13-EBA2-0549-B099-347EA568B3C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D1CAC81-7092-31A2-1F4C-69B1E9F733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0ACF173-837E-7965-FDFE-62B315411F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5BF292D-5917-22E8-8BA2-80351717DD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928A8EC-78BA-1513-E0E7-2B60064B96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8781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3D7F395-8082-3781-BC33-372F687EC0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B0D6B16-16AF-77A2-6270-913AA08818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6C73365-4026-C4D1-E1BB-7848FE49AC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D0D2D69-0749-85BA-3802-32364AFC35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AF67806-5E38-D887-7419-8C14275842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5EF6987-4D9B-406C-7B52-1CE6E20A17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FD3E176-3BE2-2930-E314-9BBEBDDBAB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FB25EE6-0993-DAC0-9C2D-57ACD3C76D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2667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A8CF5D-CF0C-F297-DB5E-2AA87C6711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D2FEB10-02FA-0C8A-205C-9C3A6B4B52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F4A9FBA-B8BA-76A3-4563-3EC477D30D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21533DA-F194-9E1B-2FCC-C4F393F2EB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63064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D70B331-3157-D570-9BF4-0D071156DB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EC01ADD-DCF4-6768-CB59-6B156E72AC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128BA38-2D86-8133-3063-FFF306E83E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59769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D74932-6AB2-91BF-84FE-444DA0D7ED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1E0F9EF-A078-895D-DBBD-0F840EFE52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C3D0B94-EE81-8DB7-CBB9-B05BE58AD0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05D8857-7189-D227-61FE-F3A4328DBE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F2523F7-6394-0B73-C801-263EDA174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0FB2513-84A6-FA41-FAA7-68EF453E73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6959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4442CA1-BBF7-5499-E7FA-33BB44C01F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5DA0F2E-CE5F-A3C4-AB22-2AD3DA542D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19833BC-8C9B-3AE2-06EC-9009F7AAEB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2657786-8983-7221-314F-48C9A1B761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AB977A7-AC9D-7580-C6D7-0C6786D3C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8D0BB81-DA15-32BA-EB49-CB2D1AACB6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35758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1940E18-12BE-16DA-C109-1D0D83446F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3A5DC55-94C8-8842-C078-8E76C72DBC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B3CC18-E4AB-C624-1ED3-389FEE54CC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08337C6-60EF-5D10-E39B-287195F46D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3F3A1BE-49DB-C36E-7D36-9B926C1132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25536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33A6B332-9145-7E04-C5AD-7A233D8E836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3975290"/>
              </p:ext>
            </p:extLst>
          </p:nvPr>
        </p:nvGraphicFramePr>
        <p:xfrm>
          <a:off x="2433484" y="2566219"/>
          <a:ext cx="6563031" cy="2477724"/>
        </p:xfrm>
        <a:graphic>
          <a:graphicData uri="http://schemas.openxmlformats.org/drawingml/2006/table">
            <a:tbl>
              <a:tblPr firstRow="1" firstCol="1" bandRow="1">
                <a:tableStyleId>{7E9639D4-E3E2-4D34-9284-5A2195B3D0D7}</a:tableStyleId>
              </a:tblPr>
              <a:tblGrid>
                <a:gridCol w="2153596">
                  <a:extLst>
                    <a:ext uri="{9D8B030D-6E8A-4147-A177-3AD203B41FA5}">
                      <a16:colId xmlns:a16="http://schemas.microsoft.com/office/drawing/2014/main" val="3880035907"/>
                    </a:ext>
                  </a:extLst>
                </a:gridCol>
                <a:gridCol w="3034022">
                  <a:extLst>
                    <a:ext uri="{9D8B030D-6E8A-4147-A177-3AD203B41FA5}">
                      <a16:colId xmlns:a16="http://schemas.microsoft.com/office/drawing/2014/main" val="294015399"/>
                    </a:ext>
                  </a:extLst>
                </a:gridCol>
                <a:gridCol w="1375413">
                  <a:extLst>
                    <a:ext uri="{9D8B030D-6E8A-4147-A177-3AD203B41FA5}">
                      <a16:colId xmlns:a16="http://schemas.microsoft.com/office/drawing/2014/main" val="600959225"/>
                    </a:ext>
                  </a:extLst>
                </a:gridCol>
              </a:tblGrid>
              <a:tr h="370599"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 dirty="0">
                          <a:effectLst/>
                        </a:rPr>
                        <a:t>Name </a:t>
                      </a:r>
                      <a:r>
                        <a:rPr lang="de-DE" sz="1200" kern="100" dirty="0" err="1">
                          <a:effectLst/>
                        </a:rPr>
                        <a:t>of</a:t>
                      </a:r>
                      <a:r>
                        <a:rPr lang="de-DE" sz="1200" kern="100" dirty="0">
                          <a:effectLst/>
                        </a:rPr>
                        <a:t> </a:t>
                      </a:r>
                      <a:r>
                        <a:rPr lang="de-DE" sz="1200" kern="100" dirty="0" err="1">
                          <a:effectLst/>
                        </a:rPr>
                        <a:t>antibody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 dirty="0">
                          <a:effectLst/>
                        </a:rPr>
                        <a:t>Vendor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Catalog number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3250675321"/>
                  </a:ext>
                </a:extLst>
              </a:tr>
              <a:tr h="234125"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anti-CD38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BioLegend (San Diego, CA, USA)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303526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val="19803640"/>
                  </a:ext>
                </a:extLst>
              </a:tr>
              <a:tr h="234125"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anti-CD138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BioLegend 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303512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val="1323713425"/>
                  </a:ext>
                </a:extLst>
              </a:tr>
              <a:tr h="234125"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anti-CD269 (BCMA)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 dirty="0" err="1">
                          <a:effectLst/>
                        </a:rPr>
                        <a:t>BioLegend</a:t>
                      </a:r>
                      <a:r>
                        <a:rPr lang="de-DE" sz="1200" kern="100" dirty="0">
                          <a:effectLst/>
                        </a:rPr>
                        <a:t> 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356508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val="1276297857"/>
                  </a:ext>
                </a:extLst>
              </a:tr>
              <a:tr h="234125"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anti-CD319 (SLAMF7)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 dirty="0" err="1">
                          <a:effectLst/>
                        </a:rPr>
                        <a:t>BioLegend</a:t>
                      </a:r>
                      <a:r>
                        <a:rPr lang="de-DE" sz="1200" kern="100" dirty="0">
                          <a:effectLst/>
                        </a:rPr>
                        <a:t> 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344722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val="88212889"/>
                  </a:ext>
                </a:extLst>
              </a:tr>
              <a:tr h="234125"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anti-CD26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Ronza (</a:t>
                      </a:r>
                      <a:r>
                        <a:rPr lang="es-ES" sz="1200" kern="100">
                          <a:effectLst/>
                        </a:rPr>
                        <a:t>Walkersville, MD, USA</a:t>
                      </a:r>
                      <a:r>
                        <a:rPr lang="de-DE" sz="1200" kern="100">
                          <a:effectLst/>
                        </a:rPr>
                        <a:t>)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300552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val="4103703165"/>
                  </a:ext>
                </a:extLst>
              </a:tr>
              <a:tr h="234125"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anti-CD55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BioLegend 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311315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val="3929195318"/>
                  </a:ext>
                </a:extLst>
              </a:tr>
              <a:tr h="234125"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anti-CD59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BioLegend 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304707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val="2962667182"/>
                  </a:ext>
                </a:extLst>
              </a:tr>
              <a:tr h="234125"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anti-annexinV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BioVision (Milpitas, CA, USA)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331806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val="2818642897"/>
                  </a:ext>
                </a:extLst>
              </a:tr>
              <a:tr h="234125"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anti-PI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>
                          <a:effectLst/>
                        </a:rPr>
                        <a:t>BioVision 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</a:pPr>
                      <a:r>
                        <a:rPr lang="de-DE" sz="1200" kern="100" dirty="0">
                          <a:effectLst/>
                        </a:rPr>
                        <a:t>357506</a:t>
                      </a:r>
                      <a:endParaRPr lang="ja-JP" sz="1000" kern="100">
                        <a:effectLst/>
                        <a:latin typeface="Times" pitchFamily="2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val="4249307180"/>
                  </a:ext>
                </a:extLst>
              </a:tr>
            </a:tbl>
          </a:graphicData>
        </a:graphic>
      </p:graphicFrame>
      <p:sp>
        <p:nvSpPr>
          <p:cNvPr id="8" name="Rectangle 2">
            <a:extLst>
              <a:ext uri="{FF2B5EF4-FFF2-40B4-BE49-F238E27FC236}">
                <a16:creationId xmlns:a16="http://schemas.microsoft.com/office/drawing/2014/main" id="{917EA25E-5EB2-1FB5-5622-FE6DED8F36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58516" y="1081950"/>
            <a:ext cx="8074967" cy="9233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en-US" altLang="ja-JP" b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</a:t>
            </a:r>
            <a:r>
              <a:rPr kumimoji="0" lang="en-US" altLang="ja-JP" b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able S2. </a:t>
            </a:r>
            <a:r>
              <a:rPr kumimoji="0" lang="ja-JP" altLang="ja-JP" b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ntibodies for immunophenotyping</a:t>
            </a:r>
            <a:r>
              <a:rPr kumimoji="0" lang="en-US" altLang="ja-JP" b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</a:t>
            </a:r>
            <a:r>
              <a:rPr kumimoji="0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en-US" altLang="ja-JP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Expression of cell surface proteins was determined by flow cytometry analysis using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en-US" altLang="ja-JP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</a:t>
            </a:r>
            <a:r>
              <a:rPr kumimoji="0" lang="en-US" altLang="ja-JP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TC-, PE-, Per-CP-, or APC-conjugated monoclonal antibodies, as shown below. </a:t>
            </a:r>
            <a:endParaRPr kumimoji="0" lang="en-US" altLang="ja-JP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93855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96</Words>
  <Application>Microsoft Macintosh PowerPoint</Application>
  <PresentationFormat>ワイド画面</PresentationFormat>
  <Paragraphs>3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Times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 </dc:creator>
  <cp:lastModifiedBy> </cp:lastModifiedBy>
  <cp:revision>9</cp:revision>
  <dcterms:created xsi:type="dcterms:W3CDTF">2024-01-06T05:47:42Z</dcterms:created>
  <dcterms:modified xsi:type="dcterms:W3CDTF">2024-01-07T06:27:38Z</dcterms:modified>
</cp:coreProperties>
</file>